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0"/>
  </p:notesMasterIdLst>
  <p:sldIdLst>
    <p:sldId id="259" r:id="rId2"/>
    <p:sldId id="265" r:id="rId3"/>
    <p:sldId id="267" r:id="rId4"/>
    <p:sldId id="268" r:id="rId5"/>
    <p:sldId id="261" r:id="rId6"/>
    <p:sldId id="262" r:id="rId7"/>
    <p:sldId id="269" r:id="rId8"/>
    <p:sldId id="270" r:id="rId9"/>
  </p:sldIdLst>
  <p:sldSz cx="7099300" cy="99441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DF3CBCE-C942-194D-9FDF-39510B991059}" v="10" dt="2023-09-13T01:44:54.04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8175"/>
    <p:restoredTop sz="94811"/>
  </p:normalViewPr>
  <p:slideViewPr>
    <p:cSldViewPr snapToGrid="0" snapToObjects="1">
      <p:cViewPr varScale="1">
        <p:scale>
          <a:sx n="76" d="100"/>
          <a:sy n="76" d="100"/>
        </p:scale>
        <p:origin x="2952" y="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2AB2F0-8C78-F04B-9CF2-282C271D267A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J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C58A72-ED85-724F-962F-3EE935DF1BE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87360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2448" y="1627426"/>
            <a:ext cx="6034405" cy="3462020"/>
          </a:xfrm>
        </p:spPr>
        <p:txBody>
          <a:bodyPr anchor="b"/>
          <a:lstStyle>
            <a:lvl1pPr algn="ctr"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87413" y="5222955"/>
            <a:ext cx="5324475" cy="2400855"/>
          </a:xfrm>
        </p:spPr>
        <p:txBody>
          <a:bodyPr/>
          <a:lstStyle>
            <a:lvl1pPr marL="0" indent="0" algn="ctr">
              <a:buNone/>
              <a:defRPr sz="1863"/>
            </a:lvl1pPr>
            <a:lvl2pPr marL="354970" indent="0" algn="ctr">
              <a:buNone/>
              <a:defRPr sz="1553"/>
            </a:lvl2pPr>
            <a:lvl3pPr marL="709940" indent="0" algn="ctr">
              <a:buNone/>
              <a:defRPr sz="1398"/>
            </a:lvl3pPr>
            <a:lvl4pPr marL="1064910" indent="0" algn="ctr">
              <a:buNone/>
              <a:defRPr sz="1242"/>
            </a:lvl4pPr>
            <a:lvl5pPr marL="1419880" indent="0" algn="ctr">
              <a:buNone/>
              <a:defRPr sz="1242"/>
            </a:lvl5pPr>
            <a:lvl6pPr marL="1774850" indent="0" algn="ctr">
              <a:buNone/>
              <a:defRPr sz="1242"/>
            </a:lvl6pPr>
            <a:lvl7pPr marL="2129820" indent="0" algn="ctr">
              <a:buNone/>
              <a:defRPr sz="1242"/>
            </a:lvl7pPr>
            <a:lvl8pPr marL="2484791" indent="0" algn="ctr">
              <a:buNone/>
              <a:defRPr sz="1242"/>
            </a:lvl8pPr>
            <a:lvl9pPr marL="2839761" indent="0" algn="ctr">
              <a:buNone/>
              <a:defRPr sz="1242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28418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359130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80437" y="529431"/>
            <a:ext cx="1530787" cy="842716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8077" y="529431"/>
            <a:ext cx="4503618" cy="842716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38687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265803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380" y="2479122"/>
            <a:ext cx="6123146" cy="4136469"/>
          </a:xfrm>
        </p:spPr>
        <p:txBody>
          <a:bodyPr anchor="b"/>
          <a:lstStyle>
            <a:lvl1pPr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80" y="6654724"/>
            <a:ext cx="6123146" cy="2175271"/>
          </a:xfrm>
        </p:spPr>
        <p:txBody>
          <a:bodyPr/>
          <a:lstStyle>
            <a:lvl1pPr marL="0" indent="0">
              <a:buNone/>
              <a:defRPr sz="1863">
                <a:solidFill>
                  <a:schemeClr val="tx1"/>
                </a:solidFill>
              </a:defRPr>
            </a:lvl1pPr>
            <a:lvl2pPr marL="354970" indent="0">
              <a:buNone/>
              <a:defRPr sz="1553">
                <a:solidFill>
                  <a:schemeClr val="tx1">
                    <a:tint val="75000"/>
                  </a:schemeClr>
                </a:solidFill>
              </a:defRPr>
            </a:lvl2pPr>
            <a:lvl3pPr marL="709940" indent="0">
              <a:buNone/>
              <a:defRPr sz="1398">
                <a:solidFill>
                  <a:schemeClr val="tx1">
                    <a:tint val="75000"/>
                  </a:schemeClr>
                </a:solidFill>
              </a:defRPr>
            </a:lvl3pPr>
            <a:lvl4pPr marL="1064910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4pPr>
            <a:lvl5pPr marL="1419880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5pPr>
            <a:lvl6pPr marL="1774850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6pPr>
            <a:lvl7pPr marL="2129820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7pPr>
            <a:lvl8pPr marL="2484791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8pPr>
            <a:lvl9pPr marL="2839761" indent="0">
              <a:buNone/>
              <a:defRPr sz="124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738114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8077" y="2647156"/>
            <a:ext cx="3017203" cy="630944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4020" y="2647156"/>
            <a:ext cx="3017203" cy="630944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31326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529434"/>
            <a:ext cx="6123146" cy="192206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9002" y="2437687"/>
            <a:ext cx="3003336" cy="119467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9002" y="3632359"/>
            <a:ext cx="3003336" cy="534265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94021" y="2437687"/>
            <a:ext cx="3018127" cy="119467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94021" y="3632359"/>
            <a:ext cx="3018127" cy="534265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304803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28757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43670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940"/>
            <a:ext cx="2289709" cy="232029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18127" y="1431769"/>
            <a:ext cx="3594021" cy="7066756"/>
          </a:xfrm>
        </p:spPr>
        <p:txBody>
          <a:bodyPr/>
          <a:lstStyle>
            <a:lvl1pPr>
              <a:defRPr sz="2484"/>
            </a:lvl1pPr>
            <a:lvl2pPr>
              <a:defRPr sz="2174"/>
            </a:lvl2pPr>
            <a:lvl3pPr>
              <a:defRPr sz="1863"/>
            </a:lvl3pPr>
            <a:lvl4pPr>
              <a:defRPr sz="1553"/>
            </a:lvl4pPr>
            <a:lvl5pPr>
              <a:defRPr sz="1553"/>
            </a:lvl5pPr>
            <a:lvl6pPr>
              <a:defRPr sz="1553"/>
            </a:lvl6pPr>
            <a:lvl7pPr>
              <a:defRPr sz="1553"/>
            </a:lvl7pPr>
            <a:lvl8pPr>
              <a:defRPr sz="1553"/>
            </a:lvl8pPr>
            <a:lvl9pPr>
              <a:defRPr sz="15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3230"/>
            <a:ext cx="2289709" cy="5526803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69992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940"/>
            <a:ext cx="2289709" cy="232029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18127" y="1431769"/>
            <a:ext cx="3594021" cy="7066756"/>
          </a:xfrm>
        </p:spPr>
        <p:txBody>
          <a:bodyPr anchor="t"/>
          <a:lstStyle>
            <a:lvl1pPr marL="0" indent="0">
              <a:buNone/>
              <a:defRPr sz="2484"/>
            </a:lvl1pPr>
            <a:lvl2pPr marL="354970" indent="0">
              <a:buNone/>
              <a:defRPr sz="2174"/>
            </a:lvl2pPr>
            <a:lvl3pPr marL="709940" indent="0">
              <a:buNone/>
              <a:defRPr sz="1863"/>
            </a:lvl3pPr>
            <a:lvl4pPr marL="1064910" indent="0">
              <a:buNone/>
              <a:defRPr sz="1553"/>
            </a:lvl4pPr>
            <a:lvl5pPr marL="1419880" indent="0">
              <a:buNone/>
              <a:defRPr sz="1553"/>
            </a:lvl5pPr>
            <a:lvl6pPr marL="1774850" indent="0">
              <a:buNone/>
              <a:defRPr sz="1553"/>
            </a:lvl6pPr>
            <a:lvl7pPr marL="2129820" indent="0">
              <a:buNone/>
              <a:defRPr sz="1553"/>
            </a:lvl7pPr>
            <a:lvl8pPr marL="2484791" indent="0">
              <a:buNone/>
              <a:defRPr sz="1553"/>
            </a:lvl8pPr>
            <a:lvl9pPr marL="2839761" indent="0">
              <a:buNone/>
              <a:defRPr sz="15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3230"/>
            <a:ext cx="2289709" cy="5526803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45015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8077" y="529434"/>
            <a:ext cx="6123146" cy="192206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8077" y="2647156"/>
            <a:ext cx="6123146" cy="63094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8077" y="9216710"/>
            <a:ext cx="1597343" cy="5294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84A67-A7B9-B543-98D5-CB565ABB4840}" type="datetimeFigureOut">
              <a:rPr lang="en-JP" smtClean="0"/>
              <a:t>09/26/202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51643" y="9216710"/>
            <a:ext cx="2396014" cy="5294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13880" y="9216710"/>
            <a:ext cx="1597343" cy="5294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0DE075-35AF-7245-B85A-CD3E3C66A25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44866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09940" rtl="0" eaLnBrk="1" latinLnBrk="0" hangingPunct="1">
        <a:lnSpc>
          <a:spcPct val="90000"/>
        </a:lnSpc>
        <a:spcBef>
          <a:spcPct val="0"/>
        </a:spcBef>
        <a:buNone/>
        <a:defRPr sz="34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7485" indent="-177485" algn="l" defTabSz="709940" rtl="0" eaLnBrk="1" latinLnBrk="0" hangingPunct="1">
        <a:lnSpc>
          <a:spcPct val="90000"/>
        </a:lnSpc>
        <a:spcBef>
          <a:spcPts val="776"/>
        </a:spcBef>
        <a:buFont typeface="Arial" panose="020B0604020202020204" pitchFamily="34" charset="0"/>
        <a:buChar char="•"/>
        <a:defRPr sz="2174" kern="1200">
          <a:solidFill>
            <a:schemeClr val="tx1"/>
          </a:solidFill>
          <a:latin typeface="+mn-lt"/>
          <a:ea typeface="+mn-ea"/>
          <a:cs typeface="+mn-cs"/>
        </a:defRPr>
      </a:lvl1pPr>
      <a:lvl2pPr marL="53245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863" kern="1200">
          <a:solidFill>
            <a:schemeClr val="tx1"/>
          </a:solidFill>
          <a:latin typeface="+mn-lt"/>
          <a:ea typeface="+mn-ea"/>
          <a:cs typeface="+mn-cs"/>
        </a:defRPr>
      </a:lvl2pPr>
      <a:lvl3pPr marL="88742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553" kern="1200">
          <a:solidFill>
            <a:schemeClr val="tx1"/>
          </a:solidFill>
          <a:latin typeface="+mn-lt"/>
          <a:ea typeface="+mn-ea"/>
          <a:cs typeface="+mn-cs"/>
        </a:defRPr>
      </a:lvl3pPr>
      <a:lvl4pPr marL="124239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59736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95233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30730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66227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301724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1pPr>
      <a:lvl2pPr marL="35497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2pPr>
      <a:lvl3pPr marL="70994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3pPr>
      <a:lvl4pPr marL="106491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41988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77485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12982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48479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283976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083301F-196C-394D-9BEF-8FC68FED4296}"/>
              </a:ext>
            </a:extLst>
          </p:cNvPr>
          <p:cNvSpPr txBox="1"/>
          <p:nvPr/>
        </p:nvSpPr>
        <p:spPr>
          <a:xfrm>
            <a:off x="0" y="289396"/>
            <a:ext cx="3326183" cy="418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121" dirty="0">
                <a:latin typeface="Helvetica" pitchFamily="2" charset="0"/>
              </a:rPr>
              <a:t>Supplementary Figure1</a:t>
            </a:r>
          </a:p>
        </p:txBody>
      </p:sp>
      <p:pic>
        <p:nvPicPr>
          <p:cNvPr id="3" name="Picture 2" descr="A picture containing text, screenshot, rectangle, businesscard&#10;&#10;Description automatically generated">
            <a:extLst>
              <a:ext uri="{FF2B5EF4-FFF2-40B4-BE49-F238E27FC236}">
                <a16:creationId xmlns:a16="http://schemas.microsoft.com/office/drawing/2014/main" id="{6C2C2DC0-E983-1B90-BBC3-8E75936A5B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300" y="1016000"/>
            <a:ext cx="6108700" cy="7912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71780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083301F-196C-394D-9BEF-8FC68FED4296}"/>
              </a:ext>
            </a:extLst>
          </p:cNvPr>
          <p:cNvSpPr txBox="1"/>
          <p:nvPr/>
        </p:nvSpPr>
        <p:spPr>
          <a:xfrm>
            <a:off x="223467" y="289396"/>
            <a:ext cx="3326183" cy="418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121" dirty="0">
                <a:latin typeface="Helvetica" pitchFamily="2" charset="0"/>
              </a:rPr>
              <a:t>Supplementary Figure2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7F6782E3-B5CC-AF46-133E-E0EFFE7122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300" y="1371600"/>
            <a:ext cx="6108700" cy="7200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86013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083301F-196C-394D-9BEF-8FC68FED4296}"/>
              </a:ext>
            </a:extLst>
          </p:cNvPr>
          <p:cNvSpPr txBox="1"/>
          <p:nvPr/>
        </p:nvSpPr>
        <p:spPr>
          <a:xfrm>
            <a:off x="223467" y="229436"/>
            <a:ext cx="3326183" cy="418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121" dirty="0">
                <a:latin typeface="Helvetica" pitchFamily="2" charset="0"/>
              </a:rPr>
              <a:t>Supplementary Figure3</a:t>
            </a:r>
          </a:p>
        </p:txBody>
      </p:sp>
      <p:pic>
        <p:nvPicPr>
          <p:cNvPr id="4" name="Picture 3" descr="A picture containing surge suppressor&#10;&#10;Description automatically generated with medium confidence">
            <a:extLst>
              <a:ext uri="{FF2B5EF4-FFF2-40B4-BE49-F238E27FC236}">
                <a16:creationId xmlns:a16="http://schemas.microsoft.com/office/drawing/2014/main" id="{96D125B0-6884-6DB9-6910-DD4B8B6418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300" y="1016000"/>
            <a:ext cx="6108700" cy="7912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5057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083301F-196C-394D-9BEF-8FC68FED4296}"/>
              </a:ext>
            </a:extLst>
          </p:cNvPr>
          <p:cNvSpPr txBox="1"/>
          <p:nvPr/>
        </p:nvSpPr>
        <p:spPr>
          <a:xfrm>
            <a:off x="223467" y="229436"/>
            <a:ext cx="3326183" cy="418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121" dirty="0">
                <a:latin typeface="Helvetica" pitchFamily="2" charset="0"/>
              </a:rPr>
              <a:t>Supplementary Figure4</a:t>
            </a:r>
          </a:p>
        </p:txBody>
      </p:sp>
      <p:pic>
        <p:nvPicPr>
          <p:cNvPr id="4" name="Picture 3" descr="A picture containing rectangle, screenshot, black, black and white&#10;&#10;Description automatically generated">
            <a:extLst>
              <a:ext uri="{FF2B5EF4-FFF2-40B4-BE49-F238E27FC236}">
                <a16:creationId xmlns:a16="http://schemas.microsoft.com/office/drawing/2014/main" id="{D99C9602-CD4C-C90A-972A-45DE1E71D8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300" y="1016000"/>
            <a:ext cx="6108700" cy="7912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82231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FDE00712-1C30-2942-ACEB-4D4E3D2EFC70}"/>
              </a:ext>
            </a:extLst>
          </p:cNvPr>
          <p:cNvSpPr txBox="1"/>
          <p:nvPr/>
        </p:nvSpPr>
        <p:spPr>
          <a:xfrm>
            <a:off x="357279" y="1578040"/>
            <a:ext cx="6384741" cy="81253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</a:rPr>
              <a:t>&gt;OsGT47A-VII_synthesised_gene			</a:t>
            </a:r>
          </a:p>
          <a:p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</a:rPr>
              <a:t>cactctgtggtctcaaatgATGGACGGTTCACACGGTTCAGCTGCTGCTCTTAGAGCTACAGGAAGATGTTTGGCACCTCTCATTATACCGGCTTCTTGTGTTGTGTGGGTTTTGTTCTTCTTCCCGAGTCCTTCCCCTGACGTTGCTGTTAGAAGGGATGGTTTCCTCCCTGCTGTTACTTTGCCTGTTCAGCGAGCAGGTGATACTCCGCCGCCTCCACCTATTATTGATGCTTCCCCTCCTCCTCCATCAACATCTCCTCCCCCACCACCACCGAGAAGAGGTAGACCTGCTAGACGAGACAGATGTGCTGGACGTTATGTTTACATGCACGAGTTGCCAAGCCGTTTTAATTCAGACCTGTTAAGAGATTGCAGGACCCTTTCTGAGTGGACTGATATGTGCAGGCATGTTGCTAATGGAGGTATTGGCCCGAGATTACCACCAGCTGCCAGAGGAGGAGTCCTACCGGCAACAGGGTGGTACGATACGAATCAATTCACGTTGGAAGTTATTTTTCATGCAAGGATGAGAAGGTATGGGTGTCTAACAGCTGATGCTTCCCGAGCAGCAGCAGTTTATGTCCCATACTATCCTGGTCTTGATGTTGGAAGGTATCTTTGGGGATTTTCTAATGGTGTTAGGGATCTGTTAGCCGAGGACCTCGCTGAATGGTTGAGAGGAACTCCAGCTTGGGCTGCTCATGGTGGAAGAGATCACTTTTTGGTTGGTGGTAGGATAGCTTGGGATTTCAGACGTGAAGATGGTGGTGGAGAAGGCTCTCAATGGGGATCAAGACTTTTGCTTCTGCCAGAAGCCATGAACATGACTGCTCTCGTGATCGAGGCATCCCCTTGGCACAGGCGAACAGATGTTGCAGTGCCCTATCCGACTTATTTTCATCCCTGGCGTCCTTCAGACGTATCTAGTTGGCAAAGGGATGCTCGACGTGCTAGACGACCTTGGTTGTTCGCTTTTGCTGGAGCAGGTAGGGGTAACGGCGACGATCATGATAGGCACCATGGAGGTGGTGTTGTGCGAGATAGAGTGATTGCCCAGTGCGCGAGATCAAGGCGTTGTGGTTTGCTGAGGTGTGGAGCCCGTGGAAGAAGAGATGATTGTTATGATCCAGGCAACGTTATGAGACTTTTCAAGTCTGCGGCCTTCTGTCTGCAGCCAAGAGGTGATAGTTACACTAGAAGATCCGTCTTTGATGCCATCCTCGCTGGGTGCGTTCCTGTTTTCTTTCATCCTGGGTCAGCATATACACAGTACAGATGGCATTTACCTCGAGATCATGCTGCTTACTCTGTCTTTGTCCCTGAGGATGGCGTCCGAAATGGAACTGTTCGATTGGAGGATGTGCTGAGAAGGGTTAGTGCTGCAAGGGTTGCCGCCATGAGAGAGCAGGTCATTAGGATGATACCAACGGTTGTATATCGTGACCCAAGGGCGCCTAGCGCTAGAGGATTCACTGATGCTATAGATGTTGCTGTTGATGGTGTGATCGAAAGGGTCAGAAGGATTAAGCAAGGTTTACCACCGGGTGGAGATGATGACGATGATCATAGGTGGGACGCCTATTTTGATACGCAAagttcgtgagaccacgaagtg			</a:t>
            </a:r>
          </a:p>
          <a:p>
            <a:r>
              <a:rPr lang="en-JP" sz="900" dirty="0">
                <a:solidFill>
                  <a:srgbClr val="000000"/>
                </a:solidFill>
                <a:latin typeface="Calibri" panose="020F0502020204030204" pitchFamily="34" charset="0"/>
              </a:rPr>
              <a:t>			</a:t>
            </a:r>
          </a:p>
          <a:p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</a:rPr>
              <a:t>&gt;AtrGT47A-VII_synthesised_gene			</a:t>
            </a:r>
          </a:p>
          <a:p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</a:rPr>
              <a:t>CACTCTGTGGTCTCAAATGATGGAAAAAAATCAAGTTGTTAATAACAGAAATGACGAATTAGTCGGTAATTTCGATAAAAATGGTGTGATCAGAAGTAAGATCGAAGAGTCTGGCCGAATCATTGACAAGTCGGGAGATATGGTGAGAAGAAACAAAGAAAACGTAACGACTTCCGAAAAGAATGGTGGAACGAGTGAAATCAATCAAGAGCTCCTTGATTCGCTGCTAAAGAACGACGTGACTAGATCTAAGAATAATGAGACTGAACCGAGTAGTCAAGAGAAGAACACAGCTTCTATTACCAATCATGGGTTTGAAAGTTCATTGACCATGAACATTAGTGCCACCCCGTTGGAGCCGGAGCCTAACCTTCATCTTCAGAAGAACTCTACCAAGACCTCTACAAAGGGTAGTCAAAATTCTAATTCAGATCTCTCATTAAACAAAAACTATTCTAATTCTAACGTTGAAGGTGAACGTAACATCGTCGATCCTTGCTTGGGTAGATACATCTACATTCACAAGTTGCCTTCTAAATTTAACAAAGACATGCTTAAGAATTGTAAGACCCTTAATGAATGGACAGATATGTGCCGATTTACTAGCAATTCTGGCATGGGAAGGCCTTTGTCAAACACAAAAGGTGTTTTGAGCAAAAACGGCTGGTATTCTACTAACCAGTTCGCTCTTGACGTGATTTTCCACAGTAGAATGAATTTGTATGAATGCCTTACTCTGAATTCGTCTGCGGCATCTGCTATATTCGTCCCGTTTTATGCTGGACTGGATATCGGTAGATATCTCTGGGCTATGAATTCTACCCTCAAGGACGCAGCTTCTATGGAGCTTATGGACTGGCTTGTTAAGAGGCCTGAGTGGAAAAGAATGCAAGGTGGTGATCATTTCATGGTCGCTGGAAGAATTACCTGGGATTTTAGAAGGTTGTCAAATTCTTCTTTAGAGTGGGGTAACGAGTTACTCATCCTCCCCGCAACTAAGAACATGACCGTTCTCGTGATCGAGAGTTCTCCTTGGTCTAGAGTAGATGTAGCTGTACCTTATCCAACATATTTCCATCCAGCCAAAGCATCAGATGTATTTTCATGGCAGAAACGTATGGCGAGGATCAAAAGGCCATGGCTTTTCAGTTTTGTGGGGGCATCTCGACCAAACATCAAGACTAGTATCCGAGATCAGCTCATTGACCAGTGTCAGAAGTCTAAGCTCTGTTATCTTTTAGAATGCAATGCACCTGGAAACCAATGTCAAAGTCCATCTTCTGTGATGAGGATCTTTCAAAGCAGTGTTTTCTGCCTTCAACCTCAAGGCGATTCTTATACCCGAAGATCTGCCTTCGATTCGATTTTGGGTGGTTGTATTCCTGTTTTTTTCCATCCTGGATCAGCATACACTCAATACCTTTGGCATCTCCCTCTAAACTATACTAAATATAGCGTCTTTATTCCAGAAGATGAAGTGAGAGATGGTGTTGTTGATATCGAAAAGAGACTTCTCGAAATAAATCGAGAGCAAGTTAGAAGTCTCAGAGATGAAGTCATCGGGCTGACTCCCAGGGTGATCTACGGTGATCCGAAAGGTAAGCTAGAGAAGTTAAAGGACGCTTTCGATATTGCTGTAGAAGGAGTGCTTAAAAGAGTGGAACGTGTTCGAAGAGGACTTGAGGGTGACCAAGGTTTTGGTGTGGAGCAGACGTGGAAACAGGTGTTACCCGAAGGGTCCTACGAAGAGGATTGGGACAGATTTTTTAAGCAGTTCGAGTTCCGAAGTTCGTGAGACCACGAAGTG			</a:t>
            </a:r>
          </a:p>
          <a:p>
            <a:r>
              <a:rPr lang="en-JP" sz="900" dirty="0">
                <a:solidFill>
                  <a:srgbClr val="000000"/>
                </a:solidFill>
                <a:latin typeface="Calibri" panose="020F0502020204030204" pitchFamily="34" charset="0"/>
              </a:rPr>
              <a:t>			</a:t>
            </a:r>
          </a:p>
          <a:p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</a:rPr>
              <a:t>&gt;AtMBGT1_synthesised_gene			</a:t>
            </a:r>
          </a:p>
          <a:p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</a:rPr>
              <a:t>CACTCTGTGGTCTCAAATGCGACCCAAGAATTATTCTCAGATGGAGAAACCCATCTCCATCACGACGGGGAAGTTTCGGACCAACAACAACAACAATCATAACAATGTCTGGTTCGTTGTTCCACTCTTCTTTATCCTCTGTTTCGTTCTCCTCTGTTTCGACTACTCTGCTCTCTTCACCGACACAGACGAAACCGCTTTCTCAATTCCCGACGTTACCCAGAAATCAACATCCTCTGAATTCACGAAAGATGACAACTTTTCTCGATTTCCCGACGACCCATCTCCTGATTCTTCCTGCTCCGGTCGGTATATTTACGTTCATGAACTTCCGTATAGATTCAATGGTGATTTGCTTGATAATTGCTTTAAGATTACTAGAGGAACCGAGAAAGATATTTGTCCTTACATCGAAAACTATGGTTTTGGTCCTGTCATTAAGAATTACGAGAATGTGTTGTTGAAACAAAGTTGGTTTACGACCAATCAGTTCATGCTCGAGGTGATATTCCACAACAAGATGATAAATTACAGATGTTTGACTAATGATTCGTCACTAGCGTCTGCGGTTTTCGTGCCGTTTTACGCAGGTCTTGATATGAGTAGGTATCTTTGGGGTTTCAACATTACGGTTAGAGATTCTTCGTCCCATGAGCTGATGGATTGGCTTGTGGTACAGAAAGAGTGGGGTCGAATGTCTGGTAGAGATCATTTCTTGGTTTCAGGAAGGATTGCTTGGGATTTCAGGAGACAGACTGATAACGAATCTGATTGGGGAAGCAAGCTTCGGTTCTTACCCGAGTCGCGGAACATGTCGATGTTGTCCATCGAATCGAGTTCTTGGAAGAATGATTACGCTATTCCGTATCCGACTTGTTTCCATCCAAGATCAGTGGATGAGATTGTGGAGTGGCAGGAGCTAATGAGGTCCCGAAAACGCGAGTATCTATTCACCTTTGCGGGTGCTCCAAGGCCTGAATATAAAGACTCGGTTCGAGGGAAGATTATAGATGAGTGTTTGGAGTCAAAGAAGCAATGTTACTTGCTAGACTGTAACTATGGGAATGTGAATTGTGACAACCCTGTCAATGTGATGAAGGTTTTCAGGAACTCGGTGTTTTGTCTCCAGCCCCCGGGTGATTCTTACACTAGAAGGTCAATGTTTGATTCAATATTGGCAGGCTGCATTCCGGTGTTCTTCCATCCAGGGACAGCGTACGCTCAATACAAGTGGCATTTGCCCAAGAATCACTCGAGTTACTCGGTTTATCTACCGGTTAAGGATGTGAAGGAGTGGAATATCAAAATCAAGGAGAGGTTGATTGAGATTCCAGAGGAAAGAGTGGTGAGGTTGAGAGAAGAGGTTATAAGGTTGATACCGAAGGTTGTCTACGCTGATCCGAAGTACGGATCGGATGGGAGTGAAGATGCATTTGAGTTGGCTGTGAAGGGAATGTTGGAGAGGATTGAAGAAGTGAGAGAGATGATGAGACAAGGGAAAGATGGTAGTGATGGGTTTGATGATAGAGATGATTATAAGTATACTTTTTCTCCATATGAAGAACCTCAAGTTTTGGCTAGTTCGTGAGACCACGAAGTG			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B8DD667-4E39-8C43-9492-561DCCCA07CD}"/>
              </a:ext>
            </a:extLst>
          </p:cNvPr>
          <p:cNvSpPr txBox="1"/>
          <p:nvPr/>
        </p:nvSpPr>
        <p:spPr>
          <a:xfrm>
            <a:off x="357279" y="599761"/>
            <a:ext cx="3326183" cy="418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121" dirty="0">
                <a:latin typeface="Helvetica" pitchFamily="2" charset="0"/>
              </a:rPr>
              <a:t>Supplementary Table1</a:t>
            </a:r>
          </a:p>
        </p:txBody>
      </p:sp>
    </p:spTree>
    <p:extLst>
      <p:ext uri="{BB962C8B-B14F-4D97-AF65-F5344CB8AC3E}">
        <p14:creationId xmlns:p14="http://schemas.microsoft.com/office/powerpoint/2010/main" val="11586628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CB8DD667-4E39-8C43-9492-561DCCCA07CD}"/>
              </a:ext>
            </a:extLst>
          </p:cNvPr>
          <p:cNvSpPr txBox="1"/>
          <p:nvPr/>
        </p:nvSpPr>
        <p:spPr>
          <a:xfrm>
            <a:off x="223466" y="953052"/>
            <a:ext cx="3326183" cy="418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121" dirty="0">
                <a:latin typeface="Helvetica" pitchFamily="2" charset="0"/>
              </a:rPr>
              <a:t>Supplementary Table2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5D0DEA5-1F58-1D81-1CE1-F00F71F022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2801419"/>
              </p:ext>
            </p:extLst>
          </p:nvPr>
        </p:nvGraphicFramePr>
        <p:xfrm>
          <a:off x="487361" y="3540423"/>
          <a:ext cx="6124575" cy="1761063"/>
        </p:xfrm>
        <a:graphic>
          <a:graphicData uri="http://schemas.openxmlformats.org/drawingml/2006/table">
            <a:tbl>
              <a:tblPr/>
              <a:tblGrid>
                <a:gridCol w="1342272">
                  <a:extLst>
                    <a:ext uri="{9D8B030D-6E8A-4147-A177-3AD203B41FA5}">
                      <a16:colId xmlns:a16="http://schemas.microsoft.com/office/drawing/2014/main" val="1489286415"/>
                    </a:ext>
                  </a:extLst>
                </a:gridCol>
                <a:gridCol w="4782303">
                  <a:extLst>
                    <a:ext uri="{9D8B030D-6E8A-4147-A177-3AD203B41FA5}">
                      <a16:colId xmlns:a16="http://schemas.microsoft.com/office/drawing/2014/main" val="3909421547"/>
                    </a:ext>
                  </a:extLst>
                </a:gridCol>
              </a:tblGrid>
              <a:tr h="18589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Primer name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Sequence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490716"/>
                  </a:ext>
                </a:extLst>
              </a:tr>
              <a:tr h="16632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OsGT47A-VII_F1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TTGCGTATCAAAATAGGCGTCC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8227934"/>
                  </a:ext>
                </a:extLst>
              </a:tr>
              <a:tr h="15653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OsGT47A-VII_F2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GGTGCCTATCATGATCGTCG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0661967"/>
                  </a:ext>
                </a:extLst>
              </a:tr>
              <a:tr h="15653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OsGT47A-VII_R1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TGGACGGTTCACACGGTT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932970"/>
                  </a:ext>
                </a:extLst>
              </a:tr>
              <a:tr h="15653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trGT47A-VII_F1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GCCAGTCCATAAGCTCCATAG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9234154"/>
                  </a:ext>
                </a:extLst>
              </a:tr>
              <a:tr h="15653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trGT47A-VII_F2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TTTGTTAAATTTAGAAGGCAAC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9214596"/>
                  </a:ext>
                </a:extLst>
              </a:tr>
              <a:tr h="15653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trGT47A-VII_R1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GCCGAATCATTGACAAGTCGGGA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9134993"/>
                  </a:ext>
                </a:extLst>
              </a:tr>
              <a:tr h="15653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tMBGT1_F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TTCACTCCCATCCGATCCGT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966124"/>
                  </a:ext>
                </a:extLst>
              </a:tr>
              <a:tr h="15653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tMBGT1_R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GGTCCCGAAAACGCGAGTATCTA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5425463"/>
                  </a:ext>
                </a:extLst>
              </a:tr>
              <a:tr h="15653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Rice_CRISPR_gRNA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TGTGGTCTCACTTGGCGCGTGGAAGATCACCTCGGTTTTAGAGCTAGAAATAGCAAG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6015562"/>
                  </a:ext>
                </a:extLst>
              </a:tr>
              <a:tr h="15653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Rice_sequence_check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CAGAAGGCAGCGCTCTTGAAC</a:t>
                      </a:r>
                    </a:p>
                  </a:txBody>
                  <a:tcPr marL="7338" marR="7338" marT="7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281599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557907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CB8DD667-4E39-8C43-9492-561DCCCA07CD}"/>
              </a:ext>
            </a:extLst>
          </p:cNvPr>
          <p:cNvSpPr txBox="1"/>
          <p:nvPr/>
        </p:nvSpPr>
        <p:spPr>
          <a:xfrm>
            <a:off x="223466" y="953052"/>
            <a:ext cx="3326183" cy="418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121">
                <a:latin typeface="Helvetica" pitchFamily="2" charset="0"/>
              </a:rPr>
              <a:t>Supplementary Table3</a:t>
            </a:r>
            <a:endParaRPr lang="en-JP" sz="2121" dirty="0">
              <a:latin typeface="Helvetica" pitchFamily="2" charset="0"/>
            </a:endParaRP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162C8A63-5194-7DD2-0A02-A3B7405BA1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8832034"/>
              </p:ext>
            </p:extLst>
          </p:nvPr>
        </p:nvGraphicFramePr>
        <p:xfrm>
          <a:off x="1" y="3954260"/>
          <a:ext cx="7099299" cy="1353070"/>
        </p:xfrm>
        <a:graphic>
          <a:graphicData uri="http://schemas.openxmlformats.org/drawingml/2006/table">
            <a:tbl>
              <a:tblPr/>
              <a:tblGrid>
                <a:gridCol w="396099">
                  <a:extLst>
                    <a:ext uri="{9D8B030D-6E8A-4147-A177-3AD203B41FA5}">
                      <a16:colId xmlns:a16="http://schemas.microsoft.com/office/drawing/2014/main" val="1462294336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1161060074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2544927351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1390433830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3885160885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1803562718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4189491619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627484245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1914850630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3800632732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804016298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4054232389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2381376730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889326008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289475160"/>
                    </a:ext>
                  </a:extLst>
                </a:gridCol>
                <a:gridCol w="446880">
                  <a:extLst>
                    <a:ext uri="{9D8B030D-6E8A-4147-A177-3AD203B41FA5}">
                      <a16:colId xmlns:a16="http://schemas.microsoft.com/office/drawing/2014/main" val="1895818124"/>
                    </a:ext>
                  </a:extLst>
                </a:gridCol>
              </a:tblGrid>
              <a:tr h="50985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ME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oung Inflorescence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florescenceP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florescenceP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florescenceP4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florescenceP5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florescenceP6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ling Root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S1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S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S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S4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S5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oungLeaf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tureLeaf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M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4284073"/>
                  </a:ext>
                </a:extLst>
              </a:tr>
              <a:tr h="509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10g32080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9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.5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6.9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8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4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6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4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0894082"/>
                  </a:ext>
                </a:extLst>
              </a:tr>
              <a:tr h="509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10g32160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.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.9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.1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.1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.5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.8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.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6.4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.8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.4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.1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9612403"/>
                  </a:ext>
                </a:extLst>
              </a:tr>
              <a:tr h="509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10g32170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.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1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.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9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8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6.6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.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3.5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0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796446"/>
                  </a:ext>
                </a:extLst>
              </a:tr>
              <a:tr h="50985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12g38450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9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.8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.7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.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8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.8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9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9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.2</a:t>
                      </a:r>
                    </a:p>
                  </a:txBody>
                  <a:tcPr marL="2390" marR="2390" marT="239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45548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213931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CB8DD667-4E39-8C43-9492-561DCCCA07CD}"/>
              </a:ext>
            </a:extLst>
          </p:cNvPr>
          <p:cNvSpPr txBox="1"/>
          <p:nvPr/>
        </p:nvSpPr>
        <p:spPr>
          <a:xfrm>
            <a:off x="223466" y="953052"/>
            <a:ext cx="3326183" cy="418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121" dirty="0">
                <a:latin typeface="Helvetica" pitchFamily="2" charset="0"/>
              </a:rPr>
              <a:t>Supplementary Table4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DE6C2DD-4659-C3C3-780F-12EB174297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4860373"/>
              </p:ext>
            </p:extLst>
          </p:nvPr>
        </p:nvGraphicFramePr>
        <p:xfrm>
          <a:off x="1125590" y="2940050"/>
          <a:ext cx="4140199" cy="4064000"/>
        </p:xfrm>
        <a:graphic>
          <a:graphicData uri="http://schemas.openxmlformats.org/drawingml/2006/table">
            <a:tbl>
              <a:tblPr/>
              <a:tblGrid>
                <a:gridCol w="828040">
                  <a:extLst>
                    <a:ext uri="{9D8B030D-6E8A-4147-A177-3AD203B41FA5}">
                      <a16:colId xmlns:a16="http://schemas.microsoft.com/office/drawing/2014/main" val="3539391097"/>
                    </a:ext>
                  </a:extLst>
                </a:gridCol>
                <a:gridCol w="1104053">
                  <a:extLst>
                    <a:ext uri="{9D8B030D-6E8A-4147-A177-3AD203B41FA5}">
                      <a16:colId xmlns:a16="http://schemas.microsoft.com/office/drawing/2014/main" val="3824010970"/>
                    </a:ext>
                  </a:extLst>
                </a:gridCol>
                <a:gridCol w="1104053">
                  <a:extLst>
                    <a:ext uri="{9D8B030D-6E8A-4147-A177-3AD203B41FA5}">
                      <a16:colId xmlns:a16="http://schemas.microsoft.com/office/drawing/2014/main" val="2164132668"/>
                    </a:ext>
                  </a:extLst>
                </a:gridCol>
                <a:gridCol w="1104053">
                  <a:extLst>
                    <a:ext uri="{9D8B030D-6E8A-4147-A177-3AD203B41FA5}">
                      <a16:colId xmlns:a16="http://schemas.microsoft.com/office/drawing/2014/main" val="871979775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oo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078075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gt47a-vii #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gt47a-vii #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863579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658499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56729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862882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.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981468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07099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850217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356393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57776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500163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o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58759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042857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gt47a-vii #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gt47a-vii #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696307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781267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06746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28467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702422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09393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JP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61885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66584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18</TotalTime>
  <Words>247</Words>
  <Application>Microsoft Office PowerPoint</Application>
  <PresentationFormat>Custom</PresentationFormat>
  <Paragraphs>16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石田 光南</dc:creator>
  <cp:lastModifiedBy>Paul Dupree</cp:lastModifiedBy>
  <cp:revision>35</cp:revision>
  <dcterms:created xsi:type="dcterms:W3CDTF">2022-04-12T13:07:13Z</dcterms:created>
  <dcterms:modified xsi:type="dcterms:W3CDTF">2023-09-26T08:40:24Z</dcterms:modified>
</cp:coreProperties>
</file>